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7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PSTT-1</a:t>
            </a:r>
            <a:endParaRPr lang="en-US" dirty="0"/>
          </a:p>
          <a:p>
            <a:endParaRPr lang="en-US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STT-1</a:t>
            </a:r>
            <a:r>
              <a:rPr lang="en-US" baseline="0" dirty="0"/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classified as negative for copy number alterations and genomic deletions affect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2801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69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4419599"/>
            <a:ext cx="8839200" cy="1542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230462"/>
            <a:ext cx="7696200" cy="4189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381000" y="368595"/>
            <a:ext cx="822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STT-1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5962471"/>
            <a:ext cx="9067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7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PSTT-1.  PSTT-1 was classified as negative for copy number alterations and genomic deletions affecting </a:t>
            </a:r>
            <a:r>
              <a:rPr lang="en-US" i="1" dirty="0"/>
              <a:t>LPCAT1 </a:t>
            </a:r>
            <a:r>
              <a:rPr lang="en-US" dirty="0"/>
              <a:t>or </a:t>
            </a:r>
            <a:r>
              <a:rPr lang="en-US" i="1" dirty="0"/>
              <a:t>TERT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4954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2</TotalTime>
  <Words>7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3</cp:revision>
  <dcterms:created xsi:type="dcterms:W3CDTF">2019-10-11T15:47:09Z</dcterms:created>
  <dcterms:modified xsi:type="dcterms:W3CDTF">2021-05-15T05:15:22Z</dcterms:modified>
</cp:coreProperties>
</file>